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media/image3.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761163" cy="993298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A211E72-074B-4058-9B04-131558C18911}"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BF49396-C0A8-45C5-8A81-7083ED87504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69559E0-171B-4C23-9E51-C5F82F3294A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8F199E6-83A1-4BE3-A360-277DD3F08EB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19773E0-F655-4E50-A2B7-6861AD52D36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81F0F6A-C821-4EB1-BBFE-CB9DC028CBE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F14724C-4545-406D-8D5E-EE060E9BE19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BB412FF-98E5-48D4-A80D-31A6F711923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6B28FD8-C0E8-431F-82CD-49203FD4F59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33D1513-FE32-486E-93A9-74739B2708C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A67C559-FB43-4FA5-9271-D961F3350CD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1007D4B-EB2D-4017-8717-00E8C2606C2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24F51AA-188A-4F11-A259-F650C0A025CE}" type="slidenum">
              <a:rPr b="0" lang="zh-CN"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1581120" y="631800"/>
            <a:ext cx="3097080" cy="5629320"/>
            <a:chOff x="1581120" y="631800"/>
            <a:chExt cx="3097080" cy="5629320"/>
          </a:xfrm>
        </p:grpSpPr>
        <p:pic>
          <p:nvPicPr>
            <p:cNvPr id="42" name="" descr=""/>
            <p:cNvPicPr/>
            <p:nvPr/>
          </p:nvPicPr>
          <p:blipFill>
            <a:blip r:embed="rId1"/>
            <a:srcRect l="0" t="14509" r="0" b="0"/>
            <a:stretch/>
          </p:blipFill>
          <p:spPr>
            <a:xfrm>
              <a:off x="1581120" y="966960"/>
              <a:ext cx="3097080" cy="5294160"/>
            </a:xfrm>
            <a:prstGeom prst="rect">
              <a:avLst/>
            </a:prstGeom>
            <a:ln w="0">
              <a:noFill/>
            </a:ln>
          </p:spPr>
        </p:pic>
        <p:sp>
          <p:nvSpPr>
            <p:cNvPr id="43" name=""/>
            <p:cNvSpPr/>
            <p:nvPr/>
          </p:nvSpPr>
          <p:spPr>
            <a:xfrm>
              <a:off x="4624560" y="4130640"/>
              <a:ext cx="0" cy="432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44" name="" descr=""/>
            <p:cNvPicPr/>
            <p:nvPr/>
          </p:nvPicPr>
          <p:blipFill>
            <a:blip r:embed="rId2"/>
            <a:stretch/>
          </p:blipFill>
          <p:spPr>
            <a:xfrm>
              <a:off x="1812960" y="5537160"/>
              <a:ext cx="463680" cy="685800"/>
            </a:xfrm>
            <a:prstGeom prst="rect">
              <a:avLst/>
            </a:prstGeom>
            <a:ln w="0">
              <a:noFill/>
            </a:ln>
          </p:spPr>
        </p:pic>
        <p:pic>
          <p:nvPicPr>
            <p:cNvPr id="45" name="" descr=""/>
            <p:cNvPicPr/>
            <p:nvPr/>
          </p:nvPicPr>
          <p:blipFill>
            <a:blip r:embed="rId3"/>
            <a:stretch/>
          </p:blipFill>
          <p:spPr>
            <a:xfrm>
              <a:off x="2914560" y="631800"/>
              <a:ext cx="647640" cy="335160"/>
            </a:xfrm>
            <a:prstGeom prst="rect">
              <a:avLst/>
            </a:prstGeom>
            <a:ln w="0">
              <a:noFill/>
            </a:ln>
          </p:spPr>
        </p:pic>
        <p:sp>
          <p:nvSpPr>
            <p:cNvPr id="46" name=""/>
            <p:cNvSpPr/>
            <p:nvPr/>
          </p:nvSpPr>
          <p:spPr>
            <a:xfrm>
              <a:off x="4619520" y="2406600"/>
              <a:ext cx="0" cy="108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 name=""/>
            <p:cNvSpPr/>
            <p:nvPr/>
          </p:nvSpPr>
          <p:spPr>
            <a:xfrm>
              <a:off x="4624560" y="4873680"/>
              <a:ext cx="0" cy="323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 name=""/>
            <p:cNvSpPr/>
            <p:nvPr/>
          </p:nvSpPr>
          <p:spPr>
            <a:xfrm>
              <a:off x="4619520" y="3479760"/>
              <a:ext cx="0" cy="108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49" name=""/>
          <p:cNvSpPr/>
          <p:nvPr/>
        </p:nvSpPr>
        <p:spPr>
          <a:xfrm>
            <a:off x="620640" y="6753240"/>
            <a:ext cx="5472360" cy="13716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rPr>
              <a:t>Additional file 5.</a:t>
            </a:r>
            <a:r>
              <a:rPr b="0" lang="en-GB" sz="1200" spc="-1" strike="noStrike">
                <a:solidFill>
                  <a:srgbClr val="000000"/>
                </a:solidFill>
                <a:latin typeface="Times New Roman"/>
              </a:rPr>
              <a:t> Hierarchical clustering display of expression profile of rice WRKY family genes in </a:t>
            </a:r>
            <a:r>
              <a:rPr b="0" i="1" lang="en-GB" sz="1200" spc="-1" strike="noStrike">
                <a:solidFill>
                  <a:srgbClr val="000000"/>
                </a:solidFill>
                <a:latin typeface="Times New Roman"/>
              </a:rPr>
              <a:t>OsWRKY13</a:t>
            </a:r>
            <a:r>
              <a:rPr b="0" lang="en-GB" sz="1200" spc="-1" strike="noStrike">
                <a:solidFill>
                  <a:srgbClr val="000000"/>
                </a:solidFill>
                <a:latin typeface="Times New Roman"/>
              </a:rPr>
              <a:t>-activated lines. (A) transgenic line D11UM1-1; (B) transgenic line D11UM7-2; M, wild-type Mudanjiang 8; 1, 2, and 3, replication 1, 2, and 3. The fold changes of expressional differences of these genes were log2 transformed, clustered using the Cluster 3.0 program, and visualized by the Treeview program (Eisen et al., 1998. Proc. Natl. Acad. Sci. USA 95:14863–14868 ). Vertical lines on the right side indicate the genes that were further analyzed (Figure 1).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4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8-07T13:41:49Z</dcterms:created>
  <dc:creator>wangyan</dc:creator>
  <dc:description/>
  <dc:language>en-US</dc:language>
  <cp:lastModifiedBy>Shiping Wang</cp:lastModifiedBy>
  <dcterms:modified xsi:type="dcterms:W3CDTF">2009-01-15T08:46:24Z</dcterms:modified>
  <cp:revision>26</cp:revision>
  <dc:subject/>
  <dc:title>幻灯片 1</dc:title>
</cp:coreProperties>
</file>